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9144000" cy="6858000" type="screen4x3"/>
  <p:notesSz cx="6858000" cy="91440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74" y="19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Hiro\&#12450;&#12450;&#12501;&#12457;&#12523;&#12480;\&#12510;&#12452;&#12501;&#12457;&#12523;&#12480;\&#30123;&#23398;&#30740;&#31350;\&#12502;&#12525;&#12503;&#12524;&#12473;&#12450;&#12463;&#12488;&#12473;\B&#32676;\&#35542;&#25991;&#29992;Data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Hiro\&#12450;&#12450;&#12501;&#12457;&#12523;&#12480;\&#12510;&#12452;&#12501;&#12457;&#12523;&#12480;\&#30123;&#23398;&#30740;&#31350;\&#12502;&#12525;&#12503;&#12524;&#12473;&#12450;&#12463;&#12488;&#12473;\B&#32676;\&#35542;&#25991;&#29992;Data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Hiro\&#12450;&#12450;&#12501;&#12457;&#12523;&#12480;\&#12510;&#12452;&#12501;&#12457;&#12523;&#12480;\&#30123;&#23398;&#30740;&#31350;\&#12502;&#12525;&#12503;&#12524;&#12473;&#12450;&#12463;&#12488;&#12473;\B&#32676;\&#35542;&#25991;&#29992;Data.xlsx" TargetMode="External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2761950976097067"/>
          <c:y val="6.6894532652863839E-2"/>
          <c:w val="0.70638780237202303"/>
          <c:h val="0.78949482896164558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3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HbA1c vs inflammmation'!$AB$48:$AB$86</c:f>
              <c:strCache>
                <c:ptCount val="39"/>
                <c:pt idx="0">
                  <c:v>3.7</c:v>
                </c:pt>
                <c:pt idx="1">
                  <c:v>1.3</c:v>
                </c:pt>
                <c:pt idx="2">
                  <c:v>1.3</c:v>
                </c:pt>
                <c:pt idx="3">
                  <c:v>-0.4</c:v>
                </c:pt>
                <c:pt idx="4">
                  <c:v>-0.4</c:v>
                </c:pt>
                <c:pt idx="5">
                  <c:v>0.4</c:v>
                </c:pt>
                <c:pt idx="6">
                  <c:v>1.5</c:v>
                </c:pt>
                <c:pt idx="7">
                  <c:v>4.1</c:v>
                </c:pt>
                <c:pt idx="8">
                  <c:v>-1.7</c:v>
                </c:pt>
                <c:pt idx="9">
                  <c:v>0.2</c:v>
                </c:pt>
                <c:pt idx="10">
                  <c:v>1</c:v>
                </c:pt>
                <c:pt idx="11">
                  <c:v>0.7</c:v>
                </c:pt>
                <c:pt idx="12">
                  <c:v>1.4</c:v>
                </c:pt>
                <c:pt idx="13">
                  <c:v>-1.3</c:v>
                </c:pt>
                <c:pt idx="14">
                  <c:v>-0.9</c:v>
                </c:pt>
                <c:pt idx="15">
                  <c:v>2.7</c:v>
                </c:pt>
                <c:pt idx="16">
                  <c:v>0.9</c:v>
                </c:pt>
                <c:pt idx="17">
                  <c:v>0.6</c:v>
                </c:pt>
                <c:pt idx="18">
                  <c:v>-</c:v>
                </c:pt>
                <c:pt idx="19">
                  <c:v>-1.8</c:v>
                </c:pt>
                <c:pt idx="20">
                  <c:v>1.7</c:v>
                </c:pt>
                <c:pt idx="21">
                  <c:v>-2.2</c:v>
                </c:pt>
                <c:pt idx="22">
                  <c:v>1</c:v>
                </c:pt>
                <c:pt idx="23">
                  <c:v>-1.8</c:v>
                </c:pt>
                <c:pt idx="24">
                  <c:v>0.1</c:v>
                </c:pt>
                <c:pt idx="25">
                  <c:v>-4.7</c:v>
                </c:pt>
                <c:pt idx="26">
                  <c:v>0.3</c:v>
                </c:pt>
                <c:pt idx="27">
                  <c:v>1.9</c:v>
                </c:pt>
                <c:pt idx="29">
                  <c:v>-1</c:v>
                </c:pt>
                <c:pt idx="30">
                  <c:v>-7.9</c:v>
                </c:pt>
                <c:pt idx="31">
                  <c:v>1.8</c:v>
                </c:pt>
                <c:pt idx="32">
                  <c:v>-3.7</c:v>
                </c:pt>
                <c:pt idx="33">
                  <c:v>-2.5</c:v>
                </c:pt>
                <c:pt idx="34">
                  <c:v>-1.5</c:v>
                </c:pt>
                <c:pt idx="35">
                  <c:v>1.6</c:v>
                </c:pt>
                <c:pt idx="36">
                  <c:v>-0.8</c:v>
                </c:pt>
                <c:pt idx="37">
                  <c:v>4.9</c:v>
                </c:pt>
                <c:pt idx="38">
                  <c:v>2.5</c:v>
                </c:pt>
              </c:strCache>
            </c:strRef>
          </c:xVal>
          <c:yVal>
            <c:numRef>
              <c:f>'HbA1c vs inflammmation'!$AD$48:$AD$86</c:f>
              <c:numCache>
                <c:formatCode>General</c:formatCode>
                <c:ptCount val="39"/>
                <c:pt idx="0">
                  <c:v>-0.59999999999999953</c:v>
                </c:pt>
                <c:pt idx="1">
                  <c:v>-0.20000000000000109</c:v>
                </c:pt>
                <c:pt idx="2">
                  <c:v>0.30000000000000077</c:v>
                </c:pt>
                <c:pt idx="3">
                  <c:v>-0.5</c:v>
                </c:pt>
                <c:pt idx="4">
                  <c:v>-2.2999999999999989</c:v>
                </c:pt>
                <c:pt idx="5">
                  <c:v>-1.0999999999999994</c:v>
                </c:pt>
                <c:pt idx="6">
                  <c:v>-0.89999999999999958</c:v>
                </c:pt>
                <c:pt idx="7">
                  <c:v>0.80000000000000071</c:v>
                </c:pt>
                <c:pt idx="8">
                  <c:v>-0.90000000000000047</c:v>
                </c:pt>
                <c:pt idx="9">
                  <c:v>-1.4000000000000004</c:v>
                </c:pt>
                <c:pt idx="10">
                  <c:v>-0.20000000000000021</c:v>
                </c:pt>
                <c:pt idx="11">
                  <c:v>0.10000000000000053</c:v>
                </c:pt>
                <c:pt idx="12">
                  <c:v>0</c:v>
                </c:pt>
                <c:pt idx="13">
                  <c:v>-0.40000000000000036</c:v>
                </c:pt>
                <c:pt idx="14">
                  <c:v>-2.1000000000000005</c:v>
                </c:pt>
                <c:pt idx="15">
                  <c:v>-1.7000000000000002</c:v>
                </c:pt>
                <c:pt idx="16">
                  <c:v>-1.5</c:v>
                </c:pt>
                <c:pt idx="17">
                  <c:v>-2.4999999999999987</c:v>
                </c:pt>
                <c:pt idx="18">
                  <c:v>0.60000000000000064</c:v>
                </c:pt>
                <c:pt idx="19">
                  <c:v>0</c:v>
                </c:pt>
                <c:pt idx="20">
                  <c:v>-0.39999999999999958</c:v>
                </c:pt>
                <c:pt idx="21">
                  <c:v>0.20000000000000021</c:v>
                </c:pt>
                <c:pt idx="22">
                  <c:v>-0.5</c:v>
                </c:pt>
                <c:pt idx="23">
                  <c:v>-1.5999999999999994</c:v>
                </c:pt>
                <c:pt idx="24">
                  <c:v>-1.5</c:v>
                </c:pt>
                <c:pt idx="25">
                  <c:v>-0.40000000000000036</c:v>
                </c:pt>
                <c:pt idx="26">
                  <c:v>0</c:v>
                </c:pt>
                <c:pt idx="27">
                  <c:v>0.59999999999999953</c:v>
                </c:pt>
                <c:pt idx="28">
                  <c:v>-2.0000000000000009</c:v>
                </c:pt>
                <c:pt idx="29">
                  <c:v>-0.60000000000000064</c:v>
                </c:pt>
                <c:pt idx="30">
                  <c:v>-0.40000000000000036</c:v>
                </c:pt>
                <c:pt idx="31">
                  <c:v>-1.3999999999999992</c:v>
                </c:pt>
                <c:pt idx="33">
                  <c:v>-1.2000000000000002</c:v>
                </c:pt>
                <c:pt idx="34">
                  <c:v>-1.6999999999999991</c:v>
                </c:pt>
                <c:pt idx="35">
                  <c:v>1.5</c:v>
                </c:pt>
                <c:pt idx="36">
                  <c:v>-1.5000000000000009</c:v>
                </c:pt>
                <c:pt idx="37">
                  <c:v>-2.1999999999999993</c:v>
                </c:pt>
                <c:pt idx="38">
                  <c:v>0.1999999999999993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1028864"/>
        <c:axId val="91064192"/>
      </c:scatterChart>
      <c:valAx>
        <c:axId val="9102886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900">
                    <a:latin typeface="+mn-lt"/>
                  </a:defRPr>
                </a:pPr>
                <a:r>
                  <a:rPr lang="en-US" sz="900">
                    <a:latin typeface="+mn-lt"/>
                  </a:rPr>
                  <a:t>ΔHbA1c (%)</a:t>
                </a:r>
                <a:endParaRPr lang="ja-JP" sz="900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0.42352809434655436"/>
              <c:y val="0.9172025731171127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91064192"/>
        <c:crosses val="autoZero"/>
        <c:crossBetween val="midCat"/>
      </c:valAx>
      <c:valAx>
        <c:axId val="910641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>
                    <a:latin typeface="+mn-lt"/>
                  </a:defRPr>
                </a:pPr>
                <a:r>
                  <a:rPr lang="en-US" sz="900" dirty="0" smtClean="0">
                    <a:latin typeface="+mn-lt"/>
                  </a:rPr>
                  <a:t>Δ</a:t>
                </a:r>
                <a:r>
                  <a:rPr lang="en-US" altLang="ja-JP" sz="900" dirty="0" smtClean="0">
                    <a:latin typeface="+mn-lt"/>
                  </a:rPr>
                  <a:t>H</a:t>
                </a:r>
                <a:r>
                  <a:rPr lang="en-US" sz="900" dirty="0" smtClean="0">
                    <a:latin typeface="+mn-lt"/>
                  </a:rPr>
                  <a:t>s-CRP </a:t>
                </a:r>
                <a:r>
                  <a:rPr lang="en-US" sz="900" dirty="0">
                    <a:latin typeface="+mn-lt"/>
                  </a:rPr>
                  <a:t>(</a:t>
                </a:r>
                <a:r>
                  <a:rPr lang="en-US" sz="900" dirty="0" err="1">
                    <a:latin typeface="+mn-lt"/>
                  </a:rPr>
                  <a:t>ng</a:t>
                </a:r>
                <a:r>
                  <a:rPr lang="en-US" sz="900" dirty="0">
                    <a:latin typeface="+mn-lt"/>
                  </a:rPr>
                  <a:t>/ml)</a:t>
                </a:r>
                <a:endParaRPr lang="ja-JP" sz="900" dirty="0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5.4890111725148696E-2"/>
              <c:y val="0.2558952901843645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91028864"/>
        <c:crosses val="autoZero"/>
        <c:crossBetween val="midCat"/>
        <c:majorUnit val="1"/>
      </c:valAx>
    </c:plotArea>
    <c:plotVisOnly val="1"/>
    <c:dispBlanksAs val="gap"/>
    <c:showDLblsOverMax val="0"/>
  </c:chart>
  <c:txPr>
    <a:bodyPr/>
    <a:lstStyle/>
    <a:p>
      <a:pPr>
        <a:defRPr sz="800" b="0">
          <a:latin typeface="Century" pitchFamily="18" charset="0"/>
          <a:cs typeface="Arial" pitchFamily="34" charset="0"/>
        </a:defRPr>
      </a:pPr>
      <a:endParaRPr lang="ja-JP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9.6629524261103203E-2"/>
          <c:y val="2.9840452761503905E-2"/>
          <c:w val="0.86864348468250474"/>
          <c:h val="0.86333790740003413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xVal>
            <c:numRef>
              <c:f>'HbA1c vs inflammmation'!$AD$48:$AD$86</c:f>
              <c:numCache>
                <c:formatCode>General</c:formatCode>
                <c:ptCount val="39"/>
                <c:pt idx="0">
                  <c:v>-0.59999999999999953</c:v>
                </c:pt>
                <c:pt idx="1">
                  <c:v>-0.20000000000000109</c:v>
                </c:pt>
                <c:pt idx="2">
                  <c:v>0.30000000000000077</c:v>
                </c:pt>
                <c:pt idx="3">
                  <c:v>-0.5</c:v>
                </c:pt>
                <c:pt idx="4">
                  <c:v>-2.2999999999999989</c:v>
                </c:pt>
                <c:pt idx="5">
                  <c:v>-1.0999999999999994</c:v>
                </c:pt>
                <c:pt idx="6">
                  <c:v>-0.89999999999999958</c:v>
                </c:pt>
                <c:pt idx="7">
                  <c:v>0.80000000000000071</c:v>
                </c:pt>
                <c:pt idx="8">
                  <c:v>-0.90000000000000047</c:v>
                </c:pt>
                <c:pt idx="9">
                  <c:v>-1.4000000000000004</c:v>
                </c:pt>
                <c:pt idx="10">
                  <c:v>-0.20000000000000021</c:v>
                </c:pt>
                <c:pt idx="11">
                  <c:v>0.10000000000000053</c:v>
                </c:pt>
                <c:pt idx="12">
                  <c:v>0</c:v>
                </c:pt>
                <c:pt idx="13">
                  <c:v>-0.40000000000000036</c:v>
                </c:pt>
                <c:pt idx="14">
                  <c:v>-2.1000000000000005</c:v>
                </c:pt>
                <c:pt idx="15">
                  <c:v>-1.7000000000000002</c:v>
                </c:pt>
                <c:pt idx="16">
                  <c:v>-1.5</c:v>
                </c:pt>
                <c:pt idx="17">
                  <c:v>-2.4999999999999987</c:v>
                </c:pt>
                <c:pt idx="18">
                  <c:v>0.60000000000000064</c:v>
                </c:pt>
                <c:pt idx="19">
                  <c:v>0</c:v>
                </c:pt>
                <c:pt idx="20">
                  <c:v>-0.39999999999999958</c:v>
                </c:pt>
                <c:pt idx="21">
                  <c:v>0.20000000000000021</c:v>
                </c:pt>
                <c:pt idx="22">
                  <c:v>-0.5</c:v>
                </c:pt>
                <c:pt idx="23">
                  <c:v>-1.5999999999999994</c:v>
                </c:pt>
                <c:pt idx="24">
                  <c:v>-1.5</c:v>
                </c:pt>
                <c:pt idx="25">
                  <c:v>-0.40000000000000036</c:v>
                </c:pt>
                <c:pt idx="26">
                  <c:v>0</c:v>
                </c:pt>
                <c:pt idx="27">
                  <c:v>0.59999999999999953</c:v>
                </c:pt>
                <c:pt idx="28">
                  <c:v>-2.0000000000000009</c:v>
                </c:pt>
                <c:pt idx="29">
                  <c:v>-0.60000000000000064</c:v>
                </c:pt>
                <c:pt idx="30">
                  <c:v>-0.40000000000000036</c:v>
                </c:pt>
                <c:pt idx="31">
                  <c:v>-1.3999999999999992</c:v>
                </c:pt>
                <c:pt idx="33">
                  <c:v>-1.2000000000000002</c:v>
                </c:pt>
                <c:pt idx="34">
                  <c:v>-1.6999999999999991</c:v>
                </c:pt>
                <c:pt idx="35">
                  <c:v>1.5</c:v>
                </c:pt>
                <c:pt idx="36">
                  <c:v>-1.5000000000000009</c:v>
                </c:pt>
                <c:pt idx="37">
                  <c:v>-2.1999999999999993</c:v>
                </c:pt>
                <c:pt idx="38">
                  <c:v>0.19999999999999932</c:v>
                </c:pt>
              </c:numCache>
            </c:numRef>
          </c:xVal>
          <c:yVal>
            <c:numRef>
              <c:f>'HbA1c vs inflammmation'!$AE$48:$AE$86</c:f>
              <c:numCache>
                <c:formatCode>General</c:formatCode>
                <c:ptCount val="39"/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xVal>
            <c:numRef>
              <c:f>'HbA1c vs inflammmation'!$AD$48:$AD$86</c:f>
              <c:numCache>
                <c:formatCode>General</c:formatCode>
                <c:ptCount val="39"/>
                <c:pt idx="0">
                  <c:v>-0.59999999999999953</c:v>
                </c:pt>
                <c:pt idx="1">
                  <c:v>-0.20000000000000109</c:v>
                </c:pt>
                <c:pt idx="2">
                  <c:v>0.30000000000000077</c:v>
                </c:pt>
                <c:pt idx="3">
                  <c:v>-0.5</c:v>
                </c:pt>
                <c:pt idx="4">
                  <c:v>-2.2999999999999989</c:v>
                </c:pt>
                <c:pt idx="5">
                  <c:v>-1.0999999999999994</c:v>
                </c:pt>
                <c:pt idx="6">
                  <c:v>-0.89999999999999958</c:v>
                </c:pt>
                <c:pt idx="7">
                  <c:v>0.80000000000000071</c:v>
                </c:pt>
                <c:pt idx="8">
                  <c:v>-0.90000000000000047</c:v>
                </c:pt>
                <c:pt idx="9">
                  <c:v>-1.4000000000000004</c:v>
                </c:pt>
                <c:pt idx="10">
                  <c:v>-0.20000000000000021</c:v>
                </c:pt>
                <c:pt idx="11">
                  <c:v>0.10000000000000053</c:v>
                </c:pt>
                <c:pt idx="12">
                  <c:v>0</c:v>
                </c:pt>
                <c:pt idx="13">
                  <c:v>-0.40000000000000036</c:v>
                </c:pt>
                <c:pt idx="14">
                  <c:v>-2.1000000000000005</c:v>
                </c:pt>
                <c:pt idx="15">
                  <c:v>-1.7000000000000002</c:v>
                </c:pt>
                <c:pt idx="16">
                  <c:v>-1.5</c:v>
                </c:pt>
                <c:pt idx="17">
                  <c:v>-2.4999999999999987</c:v>
                </c:pt>
                <c:pt idx="18">
                  <c:v>0.60000000000000064</c:v>
                </c:pt>
                <c:pt idx="19">
                  <c:v>0</c:v>
                </c:pt>
                <c:pt idx="20">
                  <c:v>-0.39999999999999958</c:v>
                </c:pt>
                <c:pt idx="21">
                  <c:v>0.20000000000000021</c:v>
                </c:pt>
                <c:pt idx="22">
                  <c:v>-0.5</c:v>
                </c:pt>
                <c:pt idx="23">
                  <c:v>-1.5999999999999994</c:v>
                </c:pt>
                <c:pt idx="24">
                  <c:v>-1.5</c:v>
                </c:pt>
                <c:pt idx="25">
                  <c:v>-0.40000000000000036</c:v>
                </c:pt>
                <c:pt idx="26">
                  <c:v>0</c:v>
                </c:pt>
                <c:pt idx="27">
                  <c:v>0.59999999999999953</c:v>
                </c:pt>
                <c:pt idx="28">
                  <c:v>-2.0000000000000009</c:v>
                </c:pt>
                <c:pt idx="29">
                  <c:v>-0.60000000000000064</c:v>
                </c:pt>
                <c:pt idx="30">
                  <c:v>-0.40000000000000036</c:v>
                </c:pt>
                <c:pt idx="31">
                  <c:v>-1.3999999999999992</c:v>
                </c:pt>
                <c:pt idx="33">
                  <c:v>-1.2000000000000002</c:v>
                </c:pt>
                <c:pt idx="34">
                  <c:v>-1.6999999999999991</c:v>
                </c:pt>
                <c:pt idx="35">
                  <c:v>1.5</c:v>
                </c:pt>
                <c:pt idx="36">
                  <c:v>-1.5000000000000009</c:v>
                </c:pt>
                <c:pt idx="37">
                  <c:v>-2.1999999999999993</c:v>
                </c:pt>
                <c:pt idx="38">
                  <c:v>0.19999999999999932</c:v>
                </c:pt>
              </c:numCache>
            </c:numRef>
          </c:xVal>
          <c:yVal>
            <c:numRef>
              <c:f>'HbA1c vs inflammmation'!$AF$48:$AF$86</c:f>
              <c:numCache>
                <c:formatCode>General</c:formatCode>
                <c:ptCount val="39"/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diamond"/>
            <c:size val="3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HbA1c vs inflammmation'!$AD$48:$AD$86</c:f>
              <c:numCache>
                <c:formatCode>General</c:formatCode>
                <c:ptCount val="39"/>
                <c:pt idx="0">
                  <c:v>-0.59999999999999953</c:v>
                </c:pt>
                <c:pt idx="1">
                  <c:v>-0.20000000000000109</c:v>
                </c:pt>
                <c:pt idx="2">
                  <c:v>0.30000000000000077</c:v>
                </c:pt>
                <c:pt idx="3">
                  <c:v>-0.5</c:v>
                </c:pt>
                <c:pt idx="4">
                  <c:v>-2.2999999999999989</c:v>
                </c:pt>
                <c:pt idx="5">
                  <c:v>-1.0999999999999994</c:v>
                </c:pt>
                <c:pt idx="6">
                  <c:v>-0.89999999999999958</c:v>
                </c:pt>
                <c:pt idx="7">
                  <c:v>0.80000000000000071</c:v>
                </c:pt>
                <c:pt idx="8">
                  <c:v>-0.90000000000000047</c:v>
                </c:pt>
                <c:pt idx="9">
                  <c:v>-1.4000000000000004</c:v>
                </c:pt>
                <c:pt idx="10">
                  <c:v>-0.20000000000000021</c:v>
                </c:pt>
                <c:pt idx="11">
                  <c:v>0.10000000000000053</c:v>
                </c:pt>
                <c:pt idx="12">
                  <c:v>0</c:v>
                </c:pt>
                <c:pt idx="13">
                  <c:v>-0.40000000000000036</c:v>
                </c:pt>
                <c:pt idx="14">
                  <c:v>-2.1000000000000005</c:v>
                </c:pt>
                <c:pt idx="15">
                  <c:v>-1.7000000000000002</c:v>
                </c:pt>
                <c:pt idx="16">
                  <c:v>-1.5</c:v>
                </c:pt>
                <c:pt idx="17">
                  <c:v>-2.4999999999999987</c:v>
                </c:pt>
                <c:pt idx="18">
                  <c:v>0.60000000000000064</c:v>
                </c:pt>
                <c:pt idx="19">
                  <c:v>0</c:v>
                </c:pt>
                <c:pt idx="20">
                  <c:v>-0.39999999999999958</c:v>
                </c:pt>
                <c:pt idx="21">
                  <c:v>0.20000000000000021</c:v>
                </c:pt>
                <c:pt idx="22">
                  <c:v>-0.5</c:v>
                </c:pt>
                <c:pt idx="23">
                  <c:v>-1.5999999999999994</c:v>
                </c:pt>
                <c:pt idx="24">
                  <c:v>-1.5</c:v>
                </c:pt>
                <c:pt idx="25">
                  <c:v>-0.40000000000000036</c:v>
                </c:pt>
                <c:pt idx="26">
                  <c:v>0</c:v>
                </c:pt>
                <c:pt idx="27">
                  <c:v>0.59999999999999953</c:v>
                </c:pt>
                <c:pt idx="28">
                  <c:v>-2.0000000000000009</c:v>
                </c:pt>
                <c:pt idx="29">
                  <c:v>-0.60000000000000064</c:v>
                </c:pt>
                <c:pt idx="30">
                  <c:v>-0.40000000000000036</c:v>
                </c:pt>
                <c:pt idx="31">
                  <c:v>-1.3999999999999992</c:v>
                </c:pt>
                <c:pt idx="33">
                  <c:v>-1.2000000000000002</c:v>
                </c:pt>
                <c:pt idx="34">
                  <c:v>-1.6999999999999991</c:v>
                </c:pt>
                <c:pt idx="35">
                  <c:v>1.5</c:v>
                </c:pt>
                <c:pt idx="36">
                  <c:v>-1.5000000000000009</c:v>
                </c:pt>
                <c:pt idx="37">
                  <c:v>-2.1999999999999993</c:v>
                </c:pt>
                <c:pt idx="38">
                  <c:v>0.19999999999999932</c:v>
                </c:pt>
              </c:numCache>
            </c:numRef>
          </c:xVal>
          <c:yVal>
            <c:numRef>
              <c:f>'HbA1c vs inflammmation'!$AG$48:$AG$86</c:f>
              <c:numCache>
                <c:formatCode>General</c:formatCode>
                <c:ptCount val="39"/>
                <c:pt idx="0">
                  <c:v>-92</c:v>
                </c:pt>
                <c:pt idx="1">
                  <c:v>-159</c:v>
                </c:pt>
                <c:pt idx="2">
                  <c:v>24</c:v>
                </c:pt>
                <c:pt idx="3">
                  <c:v>-108</c:v>
                </c:pt>
                <c:pt idx="4">
                  <c:v>-140</c:v>
                </c:pt>
                <c:pt idx="5">
                  <c:v>-30</c:v>
                </c:pt>
                <c:pt idx="6">
                  <c:v>-61</c:v>
                </c:pt>
                <c:pt idx="7">
                  <c:v>72</c:v>
                </c:pt>
                <c:pt idx="8">
                  <c:v>64</c:v>
                </c:pt>
                <c:pt idx="9">
                  <c:v>91</c:v>
                </c:pt>
                <c:pt idx="10">
                  <c:v>254</c:v>
                </c:pt>
                <c:pt idx="11">
                  <c:v>-43</c:v>
                </c:pt>
                <c:pt idx="12">
                  <c:v>-266</c:v>
                </c:pt>
                <c:pt idx="13">
                  <c:v>-83</c:v>
                </c:pt>
                <c:pt idx="14">
                  <c:v>-224</c:v>
                </c:pt>
                <c:pt idx="15">
                  <c:v>118</c:v>
                </c:pt>
                <c:pt idx="16">
                  <c:v>-201</c:v>
                </c:pt>
                <c:pt idx="17">
                  <c:v>-126</c:v>
                </c:pt>
                <c:pt idx="18">
                  <c:v>76</c:v>
                </c:pt>
                <c:pt idx="19">
                  <c:v>42</c:v>
                </c:pt>
                <c:pt idx="20">
                  <c:v>-9</c:v>
                </c:pt>
                <c:pt idx="21">
                  <c:v>-205</c:v>
                </c:pt>
                <c:pt idx="22">
                  <c:v>154</c:v>
                </c:pt>
                <c:pt idx="23">
                  <c:v>-102</c:v>
                </c:pt>
                <c:pt idx="24">
                  <c:v>33</c:v>
                </c:pt>
                <c:pt idx="25">
                  <c:v>18</c:v>
                </c:pt>
                <c:pt idx="26">
                  <c:v>289</c:v>
                </c:pt>
                <c:pt idx="27">
                  <c:v>43</c:v>
                </c:pt>
                <c:pt idx="28">
                  <c:v>62</c:v>
                </c:pt>
                <c:pt idx="29">
                  <c:v>-152</c:v>
                </c:pt>
                <c:pt idx="30">
                  <c:v>115</c:v>
                </c:pt>
                <c:pt idx="31">
                  <c:v>-32</c:v>
                </c:pt>
                <c:pt idx="32">
                  <c:v>-150</c:v>
                </c:pt>
                <c:pt idx="33">
                  <c:v>-29</c:v>
                </c:pt>
                <c:pt idx="34">
                  <c:v>93</c:v>
                </c:pt>
                <c:pt idx="35">
                  <c:v>37</c:v>
                </c:pt>
                <c:pt idx="36">
                  <c:v>-37</c:v>
                </c:pt>
                <c:pt idx="37">
                  <c:v>-139</c:v>
                </c:pt>
                <c:pt idx="38">
                  <c:v>9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6447616"/>
        <c:axId val="106449920"/>
      </c:scatterChart>
      <c:valAx>
        <c:axId val="10644761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 algn="ctr" rtl="0">
                  <a:defRPr sz="900">
                    <a:latin typeface="+mn-lt"/>
                  </a:defRPr>
                </a:pPr>
                <a:r>
                  <a:rPr lang="en-US" sz="900">
                    <a:latin typeface="+mn-lt"/>
                  </a:rPr>
                  <a:t>ΔHbA1c (%)</a:t>
                </a:r>
                <a:endParaRPr lang="ja-JP" sz="900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0.43829877972346221"/>
              <c:y val="0.9279602269495478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06449920"/>
        <c:crosses val="autoZero"/>
        <c:crossBetween val="midCat"/>
      </c:valAx>
      <c:valAx>
        <c:axId val="10644992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 algn="ctr" rtl="0">
                  <a:defRPr sz="900">
                    <a:latin typeface="+mn-lt"/>
                  </a:defRPr>
                </a:pPr>
                <a:r>
                  <a:rPr lang="en-US" sz="900">
                    <a:latin typeface="+mn-lt"/>
                  </a:rPr>
                  <a:t>ΔVCAM-1 (ng/ml)</a:t>
                </a:r>
                <a:endParaRPr lang="ja-JP" sz="900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2.6569559577726554E-2"/>
              <c:y val="0.277234212359934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0644761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800" b="0">
          <a:latin typeface="Century" pitchFamily="18" charset="0"/>
          <a:ea typeface="+mn-ea"/>
        </a:defRPr>
      </a:pPr>
      <a:endParaRPr lang="ja-JP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3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HbA1c vs inflammmation'!$V$48:$V$86</c:f>
              <c:numCache>
                <c:formatCode>General</c:formatCode>
                <c:ptCount val="39"/>
                <c:pt idx="0">
                  <c:v>-0.59999999999999953</c:v>
                </c:pt>
                <c:pt idx="1">
                  <c:v>-0.20000000000000109</c:v>
                </c:pt>
                <c:pt idx="2">
                  <c:v>0.30000000000000077</c:v>
                </c:pt>
                <c:pt idx="3">
                  <c:v>-0.5</c:v>
                </c:pt>
                <c:pt idx="4">
                  <c:v>-2.2999999999999989</c:v>
                </c:pt>
                <c:pt idx="5">
                  <c:v>-1.0999999999999994</c:v>
                </c:pt>
                <c:pt idx="6">
                  <c:v>-0.89999999999999958</c:v>
                </c:pt>
                <c:pt idx="7">
                  <c:v>0.80000000000000071</c:v>
                </c:pt>
                <c:pt idx="8">
                  <c:v>-0.90000000000000047</c:v>
                </c:pt>
                <c:pt idx="9">
                  <c:v>-1.4000000000000004</c:v>
                </c:pt>
                <c:pt idx="10">
                  <c:v>-0.20000000000000021</c:v>
                </c:pt>
                <c:pt idx="11">
                  <c:v>0.10000000000000053</c:v>
                </c:pt>
                <c:pt idx="12">
                  <c:v>0</c:v>
                </c:pt>
                <c:pt idx="13">
                  <c:v>-0.40000000000000036</c:v>
                </c:pt>
                <c:pt idx="14">
                  <c:v>-2.1000000000000005</c:v>
                </c:pt>
                <c:pt idx="15">
                  <c:v>-1.7000000000000002</c:v>
                </c:pt>
                <c:pt idx="16">
                  <c:v>-1.5</c:v>
                </c:pt>
                <c:pt idx="18">
                  <c:v>0.60000000000000064</c:v>
                </c:pt>
                <c:pt idx="19">
                  <c:v>0</c:v>
                </c:pt>
                <c:pt idx="20">
                  <c:v>-0.39999999999999958</c:v>
                </c:pt>
                <c:pt idx="21">
                  <c:v>0.20000000000000021</c:v>
                </c:pt>
                <c:pt idx="22">
                  <c:v>-0.5</c:v>
                </c:pt>
                <c:pt idx="23">
                  <c:v>-1.5999999999999994</c:v>
                </c:pt>
                <c:pt idx="24">
                  <c:v>-1.5</c:v>
                </c:pt>
                <c:pt idx="25">
                  <c:v>-0.40000000000000036</c:v>
                </c:pt>
                <c:pt idx="26">
                  <c:v>0</c:v>
                </c:pt>
                <c:pt idx="27">
                  <c:v>0.59999999999999953</c:v>
                </c:pt>
                <c:pt idx="28">
                  <c:v>-2.0000000000000009</c:v>
                </c:pt>
                <c:pt idx="29">
                  <c:v>-0.60000000000000064</c:v>
                </c:pt>
                <c:pt idx="30">
                  <c:v>-0.40000000000000036</c:v>
                </c:pt>
                <c:pt idx="31">
                  <c:v>-1.3999999999999992</c:v>
                </c:pt>
                <c:pt idx="33">
                  <c:v>-1.2000000000000002</c:v>
                </c:pt>
                <c:pt idx="34">
                  <c:v>-1.6999999999999991</c:v>
                </c:pt>
                <c:pt idx="35">
                  <c:v>1.5</c:v>
                </c:pt>
                <c:pt idx="36">
                  <c:v>-1.5000000000000009</c:v>
                </c:pt>
                <c:pt idx="37">
                  <c:v>-2.1999999999999993</c:v>
                </c:pt>
                <c:pt idx="38">
                  <c:v>0.19999999999999932</c:v>
                </c:pt>
              </c:numCache>
            </c:numRef>
          </c:xVal>
          <c:yVal>
            <c:numRef>
              <c:f>'HbA1c vs inflammmation'!$AB$48:$AB$86</c:f>
              <c:numCache>
                <c:formatCode>General</c:formatCode>
                <c:ptCount val="39"/>
                <c:pt idx="0">
                  <c:v>3.7</c:v>
                </c:pt>
                <c:pt idx="1">
                  <c:v>1.2999999999999985</c:v>
                </c:pt>
                <c:pt idx="2">
                  <c:v>1.2999999999999985</c:v>
                </c:pt>
                <c:pt idx="3">
                  <c:v>-0.39999999999999869</c:v>
                </c:pt>
                <c:pt idx="4">
                  <c:v>-0.40000000000000036</c:v>
                </c:pt>
                <c:pt idx="5">
                  <c:v>0.40000000000000036</c:v>
                </c:pt>
                <c:pt idx="6">
                  <c:v>1.5000000000000009</c:v>
                </c:pt>
                <c:pt idx="7">
                  <c:v>4.0999999999999996</c:v>
                </c:pt>
                <c:pt idx="8">
                  <c:v>-1.6999999999999991</c:v>
                </c:pt>
                <c:pt idx="9">
                  <c:v>0.20000000000000109</c:v>
                </c:pt>
                <c:pt idx="10">
                  <c:v>1</c:v>
                </c:pt>
                <c:pt idx="11">
                  <c:v>0.70000000000000118</c:v>
                </c:pt>
                <c:pt idx="12">
                  <c:v>1.4000000000000004</c:v>
                </c:pt>
                <c:pt idx="13">
                  <c:v>-1.3000000000000007</c:v>
                </c:pt>
                <c:pt idx="14">
                  <c:v>-0.90000000000000047</c:v>
                </c:pt>
                <c:pt idx="15">
                  <c:v>2.6999999999999993</c:v>
                </c:pt>
                <c:pt idx="16">
                  <c:v>0.90000000000000047</c:v>
                </c:pt>
                <c:pt idx="17">
                  <c:v>0.60000000000000153</c:v>
                </c:pt>
                <c:pt idx="18">
                  <c:v>0</c:v>
                </c:pt>
                <c:pt idx="19">
                  <c:v>-1.8000000000000007</c:v>
                </c:pt>
                <c:pt idx="20">
                  <c:v>1.6999999999999991</c:v>
                </c:pt>
                <c:pt idx="21">
                  <c:v>-2.2000000000000011</c:v>
                </c:pt>
                <c:pt idx="22">
                  <c:v>1</c:v>
                </c:pt>
                <c:pt idx="23">
                  <c:v>-1.7999999999999985</c:v>
                </c:pt>
                <c:pt idx="24">
                  <c:v>9.9999999999999672E-2</c:v>
                </c:pt>
                <c:pt idx="25">
                  <c:v>-4.6999999999999984</c:v>
                </c:pt>
                <c:pt idx="26">
                  <c:v>0.29999999999999905</c:v>
                </c:pt>
                <c:pt idx="27">
                  <c:v>1.9000000000000006</c:v>
                </c:pt>
                <c:pt idx="29">
                  <c:v>-1</c:v>
                </c:pt>
                <c:pt idx="30">
                  <c:v>-7.8999999999999986</c:v>
                </c:pt>
                <c:pt idx="31">
                  <c:v>1.8000000000000007</c:v>
                </c:pt>
                <c:pt idx="32">
                  <c:v>-3.6999999999999993</c:v>
                </c:pt>
                <c:pt idx="33">
                  <c:v>-2.5</c:v>
                </c:pt>
                <c:pt idx="34">
                  <c:v>-1.5</c:v>
                </c:pt>
                <c:pt idx="35">
                  <c:v>1.5999999999999994</c:v>
                </c:pt>
                <c:pt idx="36">
                  <c:v>-0.80000000000000071</c:v>
                </c:pt>
                <c:pt idx="37">
                  <c:v>4.9000000000000004</c:v>
                </c:pt>
                <c:pt idx="38">
                  <c:v>2.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6457344"/>
        <c:axId val="106500864"/>
      </c:scatterChart>
      <c:valAx>
        <c:axId val="1064573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900">
                    <a:latin typeface="+mn-lt"/>
                  </a:defRPr>
                </a:pPr>
                <a:r>
                  <a:rPr lang="en-US" sz="900">
                    <a:latin typeface="+mn-lt"/>
                  </a:rPr>
                  <a:t>ΔHbA1c (%)</a:t>
                </a:r>
                <a:endParaRPr lang="ja-JP" sz="900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0.43258147811309805"/>
              <c:y val="0.9389118547681540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06500864"/>
        <c:crosses val="autoZero"/>
        <c:crossBetween val="midCat"/>
      </c:valAx>
      <c:valAx>
        <c:axId val="10650086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>
                    <a:latin typeface="+mn-lt"/>
                  </a:defRPr>
                </a:pPr>
                <a:r>
                  <a:rPr lang="en-US" sz="900">
                    <a:latin typeface="+mn-lt"/>
                  </a:rPr>
                  <a:t>ΔU-8OHdG (ng/mg.cre)</a:t>
                </a:r>
                <a:endParaRPr lang="ja-JP" sz="900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6.7782787655206594E-3"/>
              <c:y val="0.2552427821522309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0645734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800" b="0">
          <a:latin typeface="Century" pitchFamily="18" charset="0"/>
          <a:cs typeface="Arial" pitchFamily="34" charset="0"/>
        </a:defRPr>
      </a:pPr>
      <a:endParaRPr lang="ja-JP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60295A2B-3175-4AF5-83E9-CBE410E4B04F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 noProof="0" smtClean="0"/>
              <a:t>マスター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  <a:endParaRPr lang="ja-JP" altLang="en-US" noProof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60ADD4B3-6083-4E63-820B-4BEE4B1879E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3588916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8" name="Rectangle 2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4579" name="Rectangle 3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/>
            <a:endParaRPr lang="ja-JP" alt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3DAE6E-4B95-4DCE-966E-EAE8811A3BDB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BA321F-97D4-4470-9276-323FF16071A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4272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7B7277-530D-4646-9D95-A81973C66FD0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4B5936-B63B-48BC-9B8A-B950E875126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79496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FFE3E2-8947-400D-9E49-9D4563CC1EBE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5FBB44-912A-4CF9-8CC3-7BE20CF7532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689900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85811C-02F0-40D2-8175-051E3E6BC6C4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953075-6C5A-4052-909F-CE41B627101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74869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5076FE-68C4-4F2B-9F59-48EFBD830A45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BD1CCE-933B-4A5D-8E6B-247B718DA6F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076905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761AC0-E29C-450D-BB78-93D605BF9D62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2D0D95-0A1A-4811-B9DB-52998ED7948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3928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EA6F7D-54FB-445F-BB47-8887E1865F6D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43D933-1B27-4298-AE38-E98DEEBC621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40309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58CFF7-DF82-4A4C-8316-2CF266414D4C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E156AA-17A6-47D3-A3AC-6E4F5F6B7C5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155884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A8B16B-94B5-4EFE-9E15-6E6B92C113A8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F66135-FE59-47FD-A319-82A45D50D6D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231896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10B1DE-4CDB-427E-B0FC-58C532262256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12F7A0-9040-4F56-9658-699217B2DE9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226980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B94E65-055F-4BDC-B369-4FB1E9643A49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EBE581-5D86-4DBD-8536-FA462B26703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690622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 smtClean="0"/>
              <a:t>Click to edit Master title style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EF37F5F4-5F0B-4566-9DE7-6CCC1D45201A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C17D0501-B2C1-4761-83F3-8EB1A77A4DA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7914230"/>
              </p:ext>
            </p:extLst>
          </p:nvPr>
        </p:nvGraphicFramePr>
        <p:xfrm>
          <a:off x="6156176" y="1412776"/>
          <a:ext cx="2545085" cy="216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219" name="テキスト ボックス 6"/>
          <p:cNvSpPr txBox="1">
            <a:spLocks noChangeArrowheads="1"/>
          </p:cNvSpPr>
          <p:nvPr/>
        </p:nvSpPr>
        <p:spPr bwMode="auto">
          <a:xfrm>
            <a:off x="900113" y="3929281"/>
            <a:ext cx="6768231" cy="507831"/>
          </a:xfrm>
          <a:prstGeom prst="rect">
            <a:avLst/>
          </a:prstGeom>
          <a:solidFill>
            <a:srgbClr val="FFFF00"/>
          </a:solidFill>
          <a:ln>
            <a:noFill/>
          </a:ln>
          <a:extLst/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900" b="1" dirty="0">
                <a:latin typeface="Calibri" pitchFamily="1" charset="0"/>
              </a:rPr>
              <a:t>Supplementary  Figure 1</a:t>
            </a:r>
            <a:r>
              <a:rPr lang="ja-JP" altLang="en-US" sz="900" b="1" dirty="0" smtClean="0">
                <a:latin typeface="Calibri" pitchFamily="1" charset="0"/>
              </a:rPr>
              <a:t> </a:t>
            </a:r>
            <a:r>
              <a:rPr lang="en-US" altLang="ja-JP" sz="900" b="1" dirty="0" smtClean="0">
                <a:latin typeface="Calibri" pitchFamily="1" charset="0"/>
              </a:rPr>
              <a:t>. </a:t>
            </a:r>
            <a:r>
              <a:rPr lang="en-US" altLang="ja-JP" sz="900" b="1" dirty="0">
                <a:latin typeface="Calibri" pitchFamily="1" charset="0"/>
              </a:rPr>
              <a:t>Inflammatory factors vs. ⊿</a:t>
            </a:r>
            <a:r>
              <a:rPr lang="en-US" altLang="ja-JP" sz="900" b="1" dirty="0" smtClean="0">
                <a:latin typeface="Calibri" pitchFamily="1" charset="0"/>
              </a:rPr>
              <a:t>HbA1c </a:t>
            </a:r>
          </a:p>
          <a:p>
            <a:pPr eaLnBrk="1" hangingPunct="1"/>
            <a:r>
              <a:rPr lang="en-US" altLang="ja-JP" sz="900" dirty="0" smtClean="0">
                <a:latin typeface="Calibri" pitchFamily="1" charset="0"/>
                <a:cs typeface="Arial" charset="0"/>
              </a:rPr>
              <a:t>Figure </a:t>
            </a:r>
            <a:r>
              <a:rPr lang="en-US" altLang="ja-JP" sz="900" dirty="0" smtClean="0">
                <a:latin typeface="Calibri" pitchFamily="1" charset="0"/>
                <a:cs typeface="Arial" charset="0"/>
              </a:rPr>
              <a:t>1(A). </a:t>
            </a:r>
            <a:r>
              <a:rPr lang="en-US" altLang="ja-JP" sz="900" dirty="0">
                <a:latin typeface="Calibri" pitchFamily="1" charset="0"/>
              </a:rPr>
              <a:t>⊿</a:t>
            </a:r>
            <a:r>
              <a:rPr lang="en-US" altLang="ja-JP" sz="900" dirty="0">
                <a:latin typeface="Calibri" pitchFamily="1" charset="0"/>
                <a:cs typeface="Arial" charset="0"/>
              </a:rPr>
              <a:t>VCAM-1 vs. </a:t>
            </a:r>
            <a:r>
              <a:rPr lang="en-US" altLang="ja-JP" sz="900" dirty="0">
                <a:latin typeface="Calibri" pitchFamily="1" charset="0"/>
              </a:rPr>
              <a:t>⊿</a:t>
            </a:r>
            <a:r>
              <a:rPr lang="en-US" altLang="ja-JP" sz="900" dirty="0">
                <a:latin typeface="Calibri" pitchFamily="1" charset="0"/>
                <a:cs typeface="Arial" charset="0"/>
              </a:rPr>
              <a:t>HbA1c (r=0.318, P=0.058) ; Figure </a:t>
            </a:r>
            <a:r>
              <a:rPr lang="en-US" altLang="ja-JP" sz="900" dirty="0" smtClean="0">
                <a:latin typeface="Calibri" pitchFamily="1" charset="0"/>
                <a:cs typeface="Arial" charset="0"/>
              </a:rPr>
              <a:t>1(B). </a:t>
            </a:r>
            <a:r>
              <a:rPr lang="en-US" altLang="ja-JP" sz="900" dirty="0">
                <a:latin typeface="Calibri" pitchFamily="1" charset="0"/>
              </a:rPr>
              <a:t>⊿</a:t>
            </a:r>
            <a:r>
              <a:rPr lang="en-US" altLang="ja-JP" sz="900" dirty="0">
                <a:latin typeface="Calibri" pitchFamily="1" charset="0"/>
                <a:cs typeface="Arial" charset="0"/>
              </a:rPr>
              <a:t>8-OHdG vs. </a:t>
            </a:r>
            <a:r>
              <a:rPr lang="en-US" altLang="ja-JP" sz="900" dirty="0">
                <a:latin typeface="Calibri" pitchFamily="1" charset="0"/>
              </a:rPr>
              <a:t>⊿</a:t>
            </a:r>
            <a:r>
              <a:rPr lang="en-US" altLang="ja-JP" sz="900" dirty="0">
                <a:latin typeface="Calibri" pitchFamily="1" charset="0"/>
                <a:cs typeface="Arial" charset="0"/>
              </a:rPr>
              <a:t>HbA1c (r= 0.215,P=.201);  Figure </a:t>
            </a:r>
            <a:r>
              <a:rPr lang="en-US" altLang="ja-JP" sz="900" dirty="0" smtClean="0">
                <a:latin typeface="Calibri" pitchFamily="1" charset="0"/>
                <a:cs typeface="Arial" charset="0"/>
              </a:rPr>
              <a:t>1</a:t>
            </a:r>
            <a:r>
              <a:rPr lang="en-US" altLang="ja-JP" sz="900" dirty="0" smtClean="0">
                <a:latin typeface="Calibri" pitchFamily="1" charset="0"/>
                <a:cs typeface="Arial" charset="0"/>
              </a:rPr>
              <a:t>(C)</a:t>
            </a:r>
            <a:r>
              <a:rPr lang="en-US" altLang="ja-JP" sz="900" dirty="0" smtClean="0">
                <a:latin typeface="Calibri" pitchFamily="1" charset="0"/>
                <a:cs typeface="Arial" charset="0"/>
              </a:rPr>
              <a:t>. </a:t>
            </a:r>
            <a:r>
              <a:rPr lang="en-US" altLang="ja-JP" sz="900" dirty="0">
                <a:latin typeface="Calibri" pitchFamily="1" charset="0"/>
              </a:rPr>
              <a:t>⊿</a:t>
            </a:r>
            <a:r>
              <a:rPr lang="en-US" altLang="ja-JP" sz="900" dirty="0" err="1">
                <a:latin typeface="Calibri" pitchFamily="1" charset="0"/>
                <a:cs typeface="Arial" charset="0"/>
              </a:rPr>
              <a:t>Hs</a:t>
            </a:r>
            <a:r>
              <a:rPr lang="en-US" altLang="ja-JP" sz="900" dirty="0">
                <a:latin typeface="Calibri" pitchFamily="1" charset="0"/>
                <a:cs typeface="Arial" charset="0"/>
              </a:rPr>
              <a:t>-CRP vs. </a:t>
            </a:r>
            <a:r>
              <a:rPr lang="en-US" altLang="ja-JP" sz="900" dirty="0">
                <a:latin typeface="Calibri" pitchFamily="1" charset="0"/>
              </a:rPr>
              <a:t>⊿</a:t>
            </a:r>
            <a:r>
              <a:rPr lang="en-US" altLang="ja-JP" sz="900" dirty="0">
                <a:latin typeface="Calibri" pitchFamily="1" charset="0"/>
                <a:cs typeface="Arial" charset="0"/>
              </a:rPr>
              <a:t>HbA1c (r= 0.239,P=0.203</a:t>
            </a:r>
            <a:r>
              <a:rPr lang="en-US" altLang="ja-JP" sz="900" dirty="0" smtClean="0">
                <a:latin typeface="Calibri" pitchFamily="1" charset="0"/>
                <a:cs typeface="Arial" charset="0"/>
              </a:rPr>
              <a:t>)</a:t>
            </a:r>
            <a:r>
              <a:rPr lang="en-US" altLang="ja-JP" sz="900" dirty="0" smtClean="0">
                <a:latin typeface="Calibri" pitchFamily="1" charset="0"/>
              </a:rPr>
              <a:t>.</a:t>
            </a:r>
            <a:endParaRPr lang="en-US" altLang="ja-JP" sz="900" dirty="0">
              <a:latin typeface="Calibri" pitchFamily="1" charset="0"/>
              <a:cs typeface="Arial" charset="0"/>
            </a:endParaRPr>
          </a:p>
        </p:txBody>
      </p:sp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0285540"/>
              </p:ext>
            </p:extLst>
          </p:nvPr>
        </p:nvGraphicFramePr>
        <p:xfrm>
          <a:off x="467544" y="1412776"/>
          <a:ext cx="2880320" cy="2178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14186373"/>
              </p:ext>
            </p:extLst>
          </p:nvPr>
        </p:nvGraphicFramePr>
        <p:xfrm>
          <a:off x="3419872" y="1412776"/>
          <a:ext cx="2953752" cy="21349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テキスト ボックス 1"/>
          <p:cNvSpPr txBox="1"/>
          <p:nvPr/>
        </p:nvSpPr>
        <p:spPr>
          <a:xfrm>
            <a:off x="395536" y="980728"/>
            <a:ext cx="274434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9pPr>
          </a:lstStyle>
          <a:p>
            <a:r>
              <a:rPr kumimoji="1" lang="en-US" altLang="ja-JP" sz="1200" dirty="0" smtClean="0">
                <a:latin typeface="+mn-lt"/>
              </a:rPr>
              <a:t>A</a:t>
            </a:r>
            <a:endParaRPr kumimoji="1" lang="ja-JP" altLang="en-US" sz="1200" dirty="0">
              <a:latin typeface="+mn-lt"/>
            </a:endParaRPr>
          </a:p>
        </p:txBody>
      </p:sp>
      <p:sp>
        <p:nvSpPr>
          <p:cNvPr id="7" name="テキスト ボックス 5"/>
          <p:cNvSpPr txBox="1"/>
          <p:nvPr/>
        </p:nvSpPr>
        <p:spPr>
          <a:xfrm>
            <a:off x="3203848" y="980728"/>
            <a:ext cx="268022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9pPr>
          </a:lstStyle>
          <a:p>
            <a:r>
              <a:rPr kumimoji="1" lang="en-US" altLang="ja-JP" sz="1200" dirty="0" smtClean="0">
                <a:latin typeface="+mn-lt"/>
              </a:rPr>
              <a:t>B</a:t>
            </a:r>
            <a:endParaRPr kumimoji="1" lang="ja-JP" altLang="en-US" sz="1200" dirty="0">
              <a:latin typeface="+mn-lt"/>
            </a:endParaRPr>
          </a:p>
        </p:txBody>
      </p:sp>
      <p:sp>
        <p:nvSpPr>
          <p:cNvPr id="10" name="テキスト ボックス 5"/>
          <p:cNvSpPr txBox="1"/>
          <p:nvPr/>
        </p:nvSpPr>
        <p:spPr>
          <a:xfrm>
            <a:off x="6032170" y="980728"/>
            <a:ext cx="266420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9pPr>
          </a:lstStyle>
          <a:p>
            <a:r>
              <a:rPr kumimoji="1" lang="en-US" altLang="ja-JP" sz="1200" dirty="0" smtClean="0">
                <a:latin typeface="+mn-lt"/>
              </a:rPr>
              <a:t>C</a:t>
            </a:r>
            <a:endParaRPr kumimoji="1" lang="ja-JP" altLang="en-US" sz="1200" dirty="0">
              <a:latin typeface="+mn-lt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35</TotalTime>
  <Words>76</Words>
  <Application>Microsoft Office PowerPoint</Application>
  <PresentationFormat>画面に合わせる (4:3)</PresentationFormat>
  <Paragraphs>11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o</dc:creator>
  <cp:lastModifiedBy>omasa0723</cp:lastModifiedBy>
  <cp:revision>51</cp:revision>
  <dcterms:created xsi:type="dcterms:W3CDTF">2013-01-16T10:33:52Z</dcterms:created>
  <dcterms:modified xsi:type="dcterms:W3CDTF">2013-04-16T14:52:08Z</dcterms:modified>
</cp:coreProperties>
</file>